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7" r:id="rId2"/>
    <p:sldId id="260" r:id="rId3"/>
    <p:sldId id="261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50076"/>
    <a:srgbClr val="750176"/>
    <a:srgbClr val="10797A"/>
    <a:srgbClr val="9EA3FF"/>
    <a:srgbClr val="001492"/>
    <a:srgbClr val="141414"/>
    <a:srgbClr val="0C0C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036"/>
    <p:restoredTop sz="97321"/>
  </p:normalViewPr>
  <p:slideViewPr>
    <p:cSldViewPr snapToGrid="0">
      <p:cViewPr>
        <p:scale>
          <a:sx n="160" d="100"/>
          <a:sy n="160" d="100"/>
        </p:scale>
        <p:origin x="192" y="-2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750362-2588-5B41-BD81-D68B35A3D15A}" type="datetimeFigureOut">
              <a:rPr lang="en-US" smtClean="0"/>
              <a:t>9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8B79D3-EF52-0040-B8F9-AE5994492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995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8B79D3-EF52-0040-B8F9-AE599449248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602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8B79D3-EF52-0040-B8F9-AE599449248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89402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8B79D3-EF52-0040-B8F9-AE599449248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2370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487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39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63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517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230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200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072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084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45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134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408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314E0-5C50-714C-82C2-DC490D6B254F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578C6-674C-374F-9065-BD84C97A7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308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openxmlformats.org/officeDocument/2006/relationships/image" Target="../media/image13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2.png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2.wdp"/><Relationship Id="rId13" Type="http://schemas.openxmlformats.org/officeDocument/2006/relationships/image" Target="../media/image19.png"/><Relationship Id="rId18" Type="http://schemas.openxmlformats.org/officeDocument/2006/relationships/image" Target="../media/image23.jpg"/><Relationship Id="rId3" Type="http://schemas.openxmlformats.org/officeDocument/2006/relationships/image" Target="../media/image14.png"/><Relationship Id="rId7" Type="http://schemas.openxmlformats.org/officeDocument/2006/relationships/image" Target="../media/image16.png"/><Relationship Id="rId12" Type="http://schemas.microsoft.com/office/2007/relationships/hdphoto" Target="../media/hdphoto14.wdp"/><Relationship Id="rId17" Type="http://schemas.openxmlformats.org/officeDocument/2006/relationships/image" Target="../media/image22.ti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1.tif"/><Relationship Id="rId20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6" Type="http://schemas.microsoft.com/office/2007/relationships/hdphoto" Target="../media/hdphoto11.wdp"/><Relationship Id="rId11" Type="http://schemas.openxmlformats.org/officeDocument/2006/relationships/image" Target="../media/image18.png"/><Relationship Id="rId5" Type="http://schemas.openxmlformats.org/officeDocument/2006/relationships/image" Target="../media/image15.png"/><Relationship Id="rId15" Type="http://schemas.openxmlformats.org/officeDocument/2006/relationships/image" Target="../media/image20.png"/><Relationship Id="rId10" Type="http://schemas.microsoft.com/office/2007/relationships/hdphoto" Target="../media/hdphoto13.wdp"/><Relationship Id="rId19" Type="http://schemas.openxmlformats.org/officeDocument/2006/relationships/image" Target="../media/image24.jpg"/><Relationship Id="rId4" Type="http://schemas.microsoft.com/office/2007/relationships/hdphoto" Target="../media/hdphoto10.wdp"/><Relationship Id="rId9" Type="http://schemas.openxmlformats.org/officeDocument/2006/relationships/image" Target="../media/image17.png"/><Relationship Id="rId14" Type="http://schemas.microsoft.com/office/2007/relationships/hdphoto" Target="../media/hdphoto15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C3386A3F-088D-4CA5-3800-94764A6CE037}"/>
              </a:ext>
            </a:extLst>
          </p:cNvPr>
          <p:cNvGrpSpPr/>
          <p:nvPr/>
        </p:nvGrpSpPr>
        <p:grpSpPr>
          <a:xfrm>
            <a:off x="311622" y="560693"/>
            <a:ext cx="3487959" cy="1241199"/>
            <a:chOff x="863965" y="2856351"/>
            <a:chExt cx="6579361" cy="1925800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8EDBF59D-617C-4CDB-AC1A-8D4A198F56AF}"/>
                </a:ext>
              </a:extLst>
            </p:cNvPr>
            <p:cNvGrpSpPr/>
            <p:nvPr/>
          </p:nvGrpSpPr>
          <p:grpSpPr>
            <a:xfrm>
              <a:off x="863965" y="2856351"/>
              <a:ext cx="6304072" cy="1919963"/>
              <a:chOff x="1053487" y="5212080"/>
              <a:chExt cx="10507722" cy="3134259"/>
            </a:xfrm>
          </p:grpSpPr>
          <p:pic>
            <p:nvPicPr>
              <p:cNvPr id="26" name="Picture 7">
                <a:extLst>
                  <a:ext uri="{FF2B5EF4-FFF2-40B4-BE49-F238E27FC236}">
                    <a16:creationId xmlns:a16="http://schemas.microsoft.com/office/drawing/2014/main" id="{85A0B998-37CE-1B13-A874-9100CFAD7A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55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2721034" y="5600489"/>
                <a:ext cx="3124258" cy="2347440"/>
              </a:xfrm>
              <a:prstGeom prst="rect">
                <a:avLst/>
              </a:prstGeom>
            </p:spPr>
          </p:pic>
          <p:pic>
            <p:nvPicPr>
              <p:cNvPr id="23" name="Picture 4">
                <a:extLst>
                  <a:ext uri="{FF2B5EF4-FFF2-40B4-BE49-F238E27FC236}">
                    <a16:creationId xmlns:a16="http://schemas.microsoft.com/office/drawing/2014/main" id="{4094D3E0-7B79-35E3-609D-08C628CE48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55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4794106" y="5622418"/>
                <a:ext cx="3113714" cy="2317343"/>
              </a:xfrm>
              <a:prstGeom prst="rect">
                <a:avLst/>
              </a:prstGeom>
            </p:spPr>
          </p:pic>
          <p:pic>
            <p:nvPicPr>
              <p:cNvPr id="24" name="Picture 5" descr="A picture containing invertebrate&#10;&#10;Description automatically generated">
                <a:extLst>
                  <a:ext uri="{FF2B5EF4-FFF2-40B4-BE49-F238E27FC236}">
                    <a16:creationId xmlns:a16="http://schemas.microsoft.com/office/drawing/2014/main" id="{EB5C8AF9-6E09-D7A9-E1B6-5A041FF88D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55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6859691" y="5587871"/>
                <a:ext cx="3122107" cy="2394830"/>
              </a:xfrm>
              <a:prstGeom prst="rect">
                <a:avLst/>
              </a:prstGeom>
            </p:spPr>
          </p:pic>
          <p:pic>
            <p:nvPicPr>
              <p:cNvPr id="25" name="Picture 6">
                <a:extLst>
                  <a:ext uri="{FF2B5EF4-FFF2-40B4-BE49-F238E27FC236}">
                    <a16:creationId xmlns:a16="http://schemas.microsoft.com/office/drawing/2014/main" id="{66AFEB0A-43F5-E55E-D89C-CCB4702605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55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8856665" y="5628338"/>
                <a:ext cx="3107643" cy="2301445"/>
              </a:xfrm>
              <a:prstGeom prst="rect">
                <a:avLst/>
              </a:prstGeom>
            </p:spPr>
          </p:pic>
          <p:pic>
            <p:nvPicPr>
              <p:cNvPr id="27" name="Picture 8" descr="A picture containing invertebrate&#10;&#10;Description automatically generated">
                <a:extLst>
                  <a:ext uri="{FF2B5EF4-FFF2-40B4-BE49-F238E27FC236}">
                    <a16:creationId xmlns:a16="http://schemas.microsoft.com/office/drawing/2014/main" id="{7FBD595C-7DA6-5652-C3B5-F31830E3A1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55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658517" y="5608732"/>
                <a:ext cx="3119119" cy="2329180"/>
              </a:xfrm>
              <a:prstGeom prst="rect">
                <a:avLst/>
              </a:prstGeom>
            </p:spPr>
          </p:pic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F652CA1-B8EC-949A-1885-BF313E2EE984}"/>
                </a:ext>
              </a:extLst>
            </p:cNvPr>
            <p:cNvSpPr txBox="1"/>
            <p:nvPr/>
          </p:nvSpPr>
          <p:spPr>
            <a:xfrm>
              <a:off x="3418783" y="4375612"/>
              <a:ext cx="2007836" cy="382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dve-1/hsp-6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3859198-D374-77C1-5CB2-A1E2923C6570}"/>
                </a:ext>
              </a:extLst>
            </p:cNvPr>
            <p:cNvSpPr txBox="1"/>
            <p:nvPr/>
          </p:nvSpPr>
          <p:spPr>
            <a:xfrm>
              <a:off x="5787292" y="4365272"/>
              <a:ext cx="1656034" cy="382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afts-1/hsp-6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6EDD6F2-6663-2E31-2F83-D6BC37EE503E}"/>
                </a:ext>
              </a:extLst>
            </p:cNvPr>
            <p:cNvSpPr txBox="1"/>
            <p:nvPr/>
          </p:nvSpPr>
          <p:spPr>
            <a:xfrm>
              <a:off x="4659673" y="4376968"/>
              <a:ext cx="1515706" cy="382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hsf-1/hsp-6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0B4800E-26C3-31BC-B727-037A25A677D8}"/>
                </a:ext>
              </a:extLst>
            </p:cNvPr>
            <p:cNvSpPr txBox="1"/>
            <p:nvPr/>
          </p:nvSpPr>
          <p:spPr>
            <a:xfrm>
              <a:off x="2175924" y="4400123"/>
              <a:ext cx="1521990" cy="382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hsp-6/EV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2EAC717-4D24-2370-B4D4-A1E1DE80C8DC}"/>
                </a:ext>
              </a:extLst>
            </p:cNvPr>
            <p:cNvSpPr txBox="1"/>
            <p:nvPr/>
          </p:nvSpPr>
          <p:spPr>
            <a:xfrm>
              <a:off x="1306006" y="4387393"/>
              <a:ext cx="719255" cy="382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EV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76C4FD5F-A854-FCA7-A6C6-6F31E3A7EEEF}"/>
              </a:ext>
            </a:extLst>
          </p:cNvPr>
          <p:cNvGrpSpPr/>
          <p:nvPr/>
        </p:nvGrpSpPr>
        <p:grpSpPr>
          <a:xfrm>
            <a:off x="311622" y="2392495"/>
            <a:ext cx="4095107" cy="1256905"/>
            <a:chOff x="556757" y="3500608"/>
            <a:chExt cx="6017810" cy="1936966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65286422-9A5C-B966-B6AD-344851F70F43}"/>
                </a:ext>
              </a:extLst>
            </p:cNvPr>
            <p:cNvGrpSpPr/>
            <p:nvPr/>
          </p:nvGrpSpPr>
          <p:grpSpPr>
            <a:xfrm>
              <a:off x="556757" y="3500608"/>
              <a:ext cx="5280829" cy="1936966"/>
              <a:chOff x="556757" y="3500608"/>
              <a:chExt cx="5280829" cy="1936966"/>
            </a:xfrm>
          </p:grpSpPr>
          <p:pic>
            <p:nvPicPr>
              <p:cNvPr id="41" name="Picture 40" descr="A close-up of a planet&#10;&#10;Description automatically generated with low confidence">
                <a:extLst>
                  <a:ext uri="{FF2B5EF4-FFF2-40B4-BE49-F238E27FC236}">
                    <a16:creationId xmlns:a16="http://schemas.microsoft.com/office/drawing/2014/main" id="{85623BD7-A140-368B-81AA-88F18435BA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60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322477" y="3734888"/>
                <a:ext cx="1840159" cy="1371600"/>
              </a:xfrm>
              <a:prstGeom prst="rect">
                <a:avLst/>
              </a:prstGeom>
            </p:spPr>
          </p:pic>
          <p:pic>
            <p:nvPicPr>
              <p:cNvPr id="42" name="Picture 41" descr="A close-up of a planet&#10;&#10;Description automatically generated with low confidence">
                <a:extLst>
                  <a:ext uri="{FF2B5EF4-FFF2-40B4-BE49-F238E27FC236}">
                    <a16:creationId xmlns:a16="http://schemas.microsoft.com/office/drawing/2014/main" id="{29D89D83-6CA9-C307-9A19-1FDEDB7553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60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1639963" y="3734888"/>
                <a:ext cx="1840159" cy="1371600"/>
              </a:xfrm>
              <a:prstGeom prst="rect">
                <a:avLst/>
              </a:prstGeom>
            </p:spPr>
          </p:pic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BEE6D876-8CEE-6CCD-1739-ACAA2F4861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60000" contrast="4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2914219" y="3734888"/>
                <a:ext cx="1840160" cy="1371600"/>
              </a:xfrm>
              <a:prstGeom prst="rect">
                <a:avLst/>
              </a:prstGeom>
            </p:spPr>
          </p:pic>
          <p:pic>
            <p:nvPicPr>
              <p:cNvPr id="44" name="Picture 43" descr="A picture containing fish, green&#10;&#10;Description automatically generated">
                <a:extLst>
                  <a:ext uri="{FF2B5EF4-FFF2-40B4-BE49-F238E27FC236}">
                    <a16:creationId xmlns:a16="http://schemas.microsoft.com/office/drawing/2014/main" id="{FEB5E5AB-082E-FB80-1696-BDBB5C0B6B8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6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4231706" y="3734888"/>
                <a:ext cx="1840159" cy="1371600"/>
              </a:xfrm>
              <a:prstGeom prst="rect">
                <a:avLst/>
              </a:prstGeom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A59E496B-B391-D40C-D1B3-2C0657A2AFF6}"/>
                  </a:ext>
                </a:extLst>
              </p:cNvPr>
              <p:cNvSpPr txBox="1"/>
              <p:nvPr/>
            </p:nvSpPr>
            <p:spPr>
              <a:xfrm>
                <a:off x="902092" y="5025411"/>
                <a:ext cx="381826" cy="3153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EV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2B69D7C5-AA07-2866-2627-980FFE9C543B}"/>
                  </a:ext>
                </a:extLst>
              </p:cNvPr>
              <p:cNvSpPr txBox="1"/>
              <p:nvPr/>
            </p:nvSpPr>
            <p:spPr>
              <a:xfrm>
                <a:off x="1988360" y="5010702"/>
                <a:ext cx="1965996" cy="4268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solidFill>
                      <a:schemeClr val="bg1"/>
                    </a:solidFill>
                  </a:rPr>
                  <a:t>cco-1</a:t>
                </a:r>
                <a:endParaRPr lang="en-US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16A4EE28-68FE-38D4-C76F-65C8B1D293F5}"/>
                  </a:ext>
                </a:extLst>
              </p:cNvPr>
              <p:cNvSpPr txBox="1"/>
              <p:nvPr/>
            </p:nvSpPr>
            <p:spPr>
              <a:xfrm>
                <a:off x="3208502" y="5010702"/>
                <a:ext cx="1965996" cy="4268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solidFill>
                      <a:schemeClr val="bg1"/>
                    </a:solidFill>
                  </a:rPr>
                  <a:t>mrps-5</a:t>
                </a:r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904D335-9E92-34D7-9227-0B8A6D37E33C}"/>
                </a:ext>
              </a:extLst>
            </p:cNvPr>
            <p:cNvSpPr txBox="1"/>
            <p:nvPr/>
          </p:nvSpPr>
          <p:spPr>
            <a:xfrm>
              <a:off x="4608571" y="5007856"/>
              <a:ext cx="1965996" cy="426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spg-7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F1F236DC-F84D-F685-B552-27CF84602BCF}"/>
              </a:ext>
            </a:extLst>
          </p:cNvPr>
          <p:cNvSpPr txBox="1"/>
          <p:nvPr/>
        </p:nvSpPr>
        <p:spPr>
          <a:xfrm>
            <a:off x="0" y="256381"/>
            <a:ext cx="918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174835F-EABE-BFA4-D00E-FD9F6C97818D}"/>
              </a:ext>
            </a:extLst>
          </p:cNvPr>
          <p:cNvSpPr txBox="1"/>
          <p:nvPr/>
        </p:nvSpPr>
        <p:spPr>
          <a:xfrm>
            <a:off x="0" y="2009216"/>
            <a:ext cx="918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10" name="Picture 9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D509C566-CDF7-AECF-6999-91828507A59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844847" y="213841"/>
            <a:ext cx="1837777" cy="1638328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8E1BD9F2-5D88-D042-C8E2-281E5692840B}"/>
              </a:ext>
            </a:extLst>
          </p:cNvPr>
          <p:cNvSpPr txBox="1"/>
          <p:nvPr/>
        </p:nvSpPr>
        <p:spPr>
          <a:xfrm>
            <a:off x="64101" y="4131740"/>
            <a:ext cx="918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pic>
        <p:nvPicPr>
          <p:cNvPr id="127" name="Picture 126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31502F07-9194-9EAA-58A0-00D1CAFE1AE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154518" y="2009216"/>
            <a:ext cx="2028442" cy="1702890"/>
          </a:xfrm>
          <a:prstGeom prst="rect">
            <a:avLst/>
          </a:prstGeom>
        </p:spPr>
      </p:pic>
      <p:pic>
        <p:nvPicPr>
          <p:cNvPr id="4" name="Picture 3" descr="A graph of different colored columns&#10;&#10;Description automatically generated">
            <a:extLst>
              <a:ext uri="{FF2B5EF4-FFF2-40B4-BE49-F238E27FC236}">
                <a16:creationId xmlns:a16="http://schemas.microsoft.com/office/drawing/2014/main" id="{802CCFBC-B11C-28A8-D101-970FFA75F258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13845" y="4275483"/>
            <a:ext cx="2969442" cy="3959256"/>
          </a:xfrm>
          <a:prstGeom prst="rect">
            <a:avLst/>
          </a:prstGeom>
        </p:spPr>
      </p:pic>
      <p:pic>
        <p:nvPicPr>
          <p:cNvPr id="7" name="Picture 6" descr="A graph of different colored columns&#10;&#10;Description automatically generated">
            <a:extLst>
              <a:ext uri="{FF2B5EF4-FFF2-40B4-BE49-F238E27FC236}">
                <a16:creationId xmlns:a16="http://schemas.microsoft.com/office/drawing/2014/main" id="{3A40ED5D-8039-3AF4-6B63-07A25074836D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609786" y="4275483"/>
            <a:ext cx="2990805" cy="395925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B66E303-C76F-B7BE-51D4-6B3E448D7B6B}"/>
              </a:ext>
            </a:extLst>
          </p:cNvPr>
          <p:cNvSpPr txBox="1"/>
          <p:nvPr/>
        </p:nvSpPr>
        <p:spPr>
          <a:xfrm>
            <a:off x="0" y="870295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01CF93A-D4BA-2E44-157A-955372F047BF}"/>
              </a:ext>
            </a:extLst>
          </p:cNvPr>
          <p:cNvSpPr txBox="1"/>
          <p:nvPr/>
        </p:nvSpPr>
        <p:spPr>
          <a:xfrm>
            <a:off x="1435688" y="28872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u="sng" dirty="0"/>
              <a:t>hsp-4</a:t>
            </a:r>
            <a:r>
              <a:rPr lang="en-US" sz="1200" u="sng" dirty="0"/>
              <a:t>p::GFP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4659372-7D2A-6FE1-4328-B63C41613E8D}"/>
              </a:ext>
            </a:extLst>
          </p:cNvPr>
          <p:cNvSpPr txBox="1"/>
          <p:nvPr/>
        </p:nvSpPr>
        <p:spPr>
          <a:xfrm>
            <a:off x="1435688" y="2105274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u="sng" dirty="0"/>
              <a:t>hsp-4</a:t>
            </a:r>
            <a:r>
              <a:rPr lang="en-US" sz="1200" u="sng" dirty="0"/>
              <a:t>p::GFP</a:t>
            </a:r>
          </a:p>
        </p:txBody>
      </p:sp>
    </p:spTree>
    <p:extLst>
      <p:ext uri="{BB962C8B-B14F-4D97-AF65-F5344CB8AC3E}">
        <p14:creationId xmlns:p14="http://schemas.microsoft.com/office/powerpoint/2010/main" val="1435522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A1507CB-6224-A5A5-D58A-9F7566818B9B}"/>
              </a:ext>
            </a:extLst>
          </p:cNvPr>
          <p:cNvGrpSpPr/>
          <p:nvPr/>
        </p:nvGrpSpPr>
        <p:grpSpPr>
          <a:xfrm>
            <a:off x="523337" y="927036"/>
            <a:ext cx="2775934" cy="2043006"/>
            <a:chOff x="498824" y="552147"/>
            <a:chExt cx="4036163" cy="3640481"/>
          </a:xfrm>
        </p:grpSpPr>
        <p:pic>
          <p:nvPicPr>
            <p:cNvPr id="4" name="Picture 3" descr="A picture containing invertebrate&#10;&#10;Description automatically generated">
              <a:extLst>
                <a:ext uri="{FF2B5EF4-FFF2-40B4-BE49-F238E27FC236}">
                  <a16:creationId xmlns:a16="http://schemas.microsoft.com/office/drawing/2014/main" id="{87DFF3F0-78C1-6552-F5D3-56070F5FC1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8000" contrast="4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264545" y="786428"/>
              <a:ext cx="1840159" cy="13716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140845C-D9AB-67D9-F8AF-8401BCCD47A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8000" contrast="4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264544" y="2586749"/>
              <a:ext cx="1840159" cy="1371600"/>
            </a:xfrm>
            <a:prstGeom prst="rect">
              <a:avLst/>
            </a:prstGeom>
          </p:spPr>
        </p:pic>
        <p:pic>
          <p:nvPicPr>
            <p:cNvPr id="6" name="Picture 5" descr="A green leaf on a black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C9C32ADD-946B-E692-63F7-D8B98FCAA5A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8000" contrast="4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1572188" y="786427"/>
              <a:ext cx="1840159" cy="1371600"/>
            </a:xfrm>
            <a:prstGeom prst="rect">
              <a:avLst/>
            </a:prstGeom>
          </p:spPr>
        </p:pic>
        <p:pic>
          <p:nvPicPr>
            <p:cNvPr id="7" name="Picture 6" descr="A picture containing invertebrate&#10;&#10;Description automatically generated">
              <a:extLst>
                <a:ext uri="{FF2B5EF4-FFF2-40B4-BE49-F238E27FC236}">
                  <a16:creationId xmlns:a16="http://schemas.microsoft.com/office/drawing/2014/main" id="{2C29458A-3242-1526-9E60-A1E67666130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8000" contrast="4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1576685" y="2586749"/>
              <a:ext cx="1840159" cy="1371600"/>
            </a:xfrm>
            <a:prstGeom prst="rect">
              <a:avLst/>
            </a:prstGeom>
          </p:spPr>
        </p:pic>
        <p:pic>
          <p:nvPicPr>
            <p:cNvPr id="8" name="Picture 7" descr="A picture containing invertebrate&#10;&#10;Description automatically generated">
              <a:extLst>
                <a:ext uri="{FF2B5EF4-FFF2-40B4-BE49-F238E27FC236}">
                  <a16:creationId xmlns:a16="http://schemas.microsoft.com/office/drawing/2014/main" id="{050C07D4-B2FF-CAB0-100D-C7BE14EE2BF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8000" contrast="4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2927417" y="786428"/>
              <a:ext cx="1840159" cy="1371600"/>
            </a:xfrm>
            <a:prstGeom prst="rect">
              <a:avLst/>
            </a:prstGeom>
          </p:spPr>
        </p:pic>
        <p:pic>
          <p:nvPicPr>
            <p:cNvPr id="9" name="Picture 8" descr="A picture containing invertebrate&#10;&#10;Description automatically generated">
              <a:extLst>
                <a:ext uri="{FF2B5EF4-FFF2-40B4-BE49-F238E27FC236}">
                  <a16:creationId xmlns:a16="http://schemas.microsoft.com/office/drawing/2014/main" id="{8DA12672-F5A6-CF61-146A-2B811E7D54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8000" contrast="4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2929107" y="2586749"/>
              <a:ext cx="1840159" cy="1371600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8CB0E8C4-D0EA-D057-8ABF-3769A131ED71}"/>
              </a:ext>
            </a:extLst>
          </p:cNvPr>
          <p:cNvSpPr txBox="1"/>
          <p:nvPr/>
        </p:nvSpPr>
        <p:spPr>
          <a:xfrm>
            <a:off x="835347" y="887811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EV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376834A-58E8-0749-0B3B-1A702951B0DD}"/>
              </a:ext>
            </a:extLst>
          </p:cNvPr>
          <p:cNvSpPr txBox="1"/>
          <p:nvPr/>
        </p:nvSpPr>
        <p:spPr>
          <a:xfrm>
            <a:off x="712507" y="2770255"/>
            <a:ext cx="1965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hsp-6</a:t>
            </a:r>
            <a:r>
              <a:rPr lang="en-US" sz="1000" dirty="0">
                <a:solidFill>
                  <a:schemeClr val="bg1"/>
                </a:solidFill>
              </a:rPr>
              <a:t> /E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EB518C-92F0-36B3-D4E3-EEC47CDA64CC}"/>
              </a:ext>
            </a:extLst>
          </p:cNvPr>
          <p:cNvSpPr txBox="1"/>
          <p:nvPr/>
        </p:nvSpPr>
        <p:spPr>
          <a:xfrm>
            <a:off x="1525949" y="880601"/>
            <a:ext cx="943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gcn-2</a:t>
            </a:r>
            <a:r>
              <a:rPr lang="en-US" sz="1000" dirty="0">
                <a:solidFill>
                  <a:schemeClr val="bg1"/>
                </a:solidFill>
              </a:rPr>
              <a:t>/EV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E64FDB3-3B8A-EF17-C5E3-6E9D8117CB85}"/>
              </a:ext>
            </a:extLst>
          </p:cNvPr>
          <p:cNvSpPr txBox="1"/>
          <p:nvPr/>
        </p:nvSpPr>
        <p:spPr>
          <a:xfrm>
            <a:off x="1486290" y="2763047"/>
            <a:ext cx="1965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gcn-2/hsp-6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C5DD9A7-9C6F-560C-3778-06BF3A992C95}"/>
              </a:ext>
            </a:extLst>
          </p:cNvPr>
          <p:cNvSpPr txBox="1"/>
          <p:nvPr/>
        </p:nvSpPr>
        <p:spPr>
          <a:xfrm>
            <a:off x="2419532" y="2744570"/>
            <a:ext cx="1965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pek-1/hsp-6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9D05D83-AF62-AA80-6859-664ADDD1EF7C}"/>
              </a:ext>
            </a:extLst>
          </p:cNvPr>
          <p:cNvSpPr txBox="1"/>
          <p:nvPr/>
        </p:nvSpPr>
        <p:spPr>
          <a:xfrm>
            <a:off x="2469288" y="873393"/>
            <a:ext cx="1965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pek-1/</a:t>
            </a:r>
            <a:r>
              <a:rPr lang="en-US" sz="1000" dirty="0">
                <a:solidFill>
                  <a:schemeClr val="bg1"/>
                </a:solidFill>
              </a:rPr>
              <a:t>EV</a:t>
            </a:r>
          </a:p>
        </p:txBody>
      </p:sp>
      <p:pic>
        <p:nvPicPr>
          <p:cNvPr id="92" name="Picture 91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D3957834-1BB5-51ED-A1F7-6D9E16E2A15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401368" y="900623"/>
            <a:ext cx="2918440" cy="2007034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7A05C23A-9359-2A5F-833C-07094612D1A1}"/>
              </a:ext>
            </a:extLst>
          </p:cNvPr>
          <p:cNvSpPr txBox="1"/>
          <p:nvPr/>
        </p:nvSpPr>
        <p:spPr>
          <a:xfrm>
            <a:off x="186898" y="451366"/>
            <a:ext cx="381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A8E62E4-A028-4444-BF72-E6C2AD0E689E}"/>
              </a:ext>
            </a:extLst>
          </p:cNvPr>
          <p:cNvSpPr txBox="1"/>
          <p:nvPr/>
        </p:nvSpPr>
        <p:spPr>
          <a:xfrm>
            <a:off x="186898" y="3152263"/>
            <a:ext cx="381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E1B22BA-9277-5EB6-A60A-99E7BF56972D}"/>
              </a:ext>
            </a:extLst>
          </p:cNvPr>
          <p:cNvSpPr txBox="1"/>
          <p:nvPr/>
        </p:nvSpPr>
        <p:spPr>
          <a:xfrm>
            <a:off x="568436" y="3289025"/>
            <a:ext cx="1098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u="sng" dirty="0"/>
              <a:t>daf-28</a:t>
            </a:r>
            <a:r>
              <a:rPr lang="en-US" sz="1000" u="sng" dirty="0"/>
              <a:t>p::GFP 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CEADBA4-F2F5-3536-561C-3204FFACB271}"/>
              </a:ext>
            </a:extLst>
          </p:cNvPr>
          <p:cNvSpPr txBox="1"/>
          <p:nvPr/>
        </p:nvSpPr>
        <p:spPr>
          <a:xfrm>
            <a:off x="2002614" y="3293361"/>
            <a:ext cx="14040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u="sng" dirty="0"/>
              <a:t>daf-28</a:t>
            </a:r>
            <a:r>
              <a:rPr lang="en-US" sz="1000" u="sng" dirty="0"/>
              <a:t>p::DAF-28::GFP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7FCECC5-6DB3-0B6E-EEDE-F8ED3B5B6411}"/>
              </a:ext>
            </a:extLst>
          </p:cNvPr>
          <p:cNvSpPr txBox="1"/>
          <p:nvPr/>
        </p:nvSpPr>
        <p:spPr>
          <a:xfrm>
            <a:off x="0" y="870295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187E07B9-A050-489D-BAAF-66961B27F59F}"/>
              </a:ext>
            </a:extLst>
          </p:cNvPr>
          <p:cNvGrpSpPr/>
          <p:nvPr/>
        </p:nvGrpSpPr>
        <p:grpSpPr>
          <a:xfrm>
            <a:off x="544810" y="3744008"/>
            <a:ext cx="945243" cy="742372"/>
            <a:chOff x="498824" y="5265061"/>
            <a:chExt cx="686116" cy="742372"/>
          </a:xfrm>
        </p:grpSpPr>
        <p:pic>
          <p:nvPicPr>
            <p:cNvPr id="21" name="Picture 20" descr="A black and white image of a dna strand&#10;&#10;Description automatically generated">
              <a:extLst>
                <a:ext uri="{FF2B5EF4-FFF2-40B4-BE49-F238E27FC236}">
                  <a16:creationId xmlns:a16="http://schemas.microsoft.com/office/drawing/2014/main" id="{A5DBF585-B4BC-694F-FB3B-DE3D62AF05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3089" t="36928" r="69430" b="24790"/>
            <a:stretch/>
          </p:blipFill>
          <p:spPr>
            <a:xfrm>
              <a:off x="498824" y="5265061"/>
              <a:ext cx="686116" cy="588099"/>
            </a:xfrm>
            <a:prstGeom prst="rect">
              <a:avLst/>
            </a:prstGeom>
          </p:spPr>
        </p:pic>
        <p:pic>
          <p:nvPicPr>
            <p:cNvPr id="19" name="Picture 18" descr="A close-up of a dna&#10;&#10;Description automatically generated">
              <a:extLst>
                <a:ext uri="{FF2B5EF4-FFF2-40B4-BE49-F238E27FC236}">
                  <a16:creationId xmlns:a16="http://schemas.microsoft.com/office/drawing/2014/main" id="{8253B54F-4702-1020-B49E-F824312D40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815" t="50000" r="71725" b="11746"/>
            <a:stretch/>
          </p:blipFill>
          <p:spPr>
            <a:xfrm>
              <a:off x="498824" y="5419333"/>
              <a:ext cx="686116" cy="588100"/>
            </a:xfrm>
            <a:prstGeom prst="rect">
              <a:avLst/>
            </a:prstGeom>
          </p:spPr>
        </p:pic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66021722-AD6C-06BB-D09B-A115B2CA7BAA}"/>
              </a:ext>
            </a:extLst>
          </p:cNvPr>
          <p:cNvGrpSpPr/>
          <p:nvPr/>
        </p:nvGrpSpPr>
        <p:grpSpPr>
          <a:xfrm>
            <a:off x="2158306" y="3776708"/>
            <a:ext cx="945243" cy="745708"/>
            <a:chOff x="2473851" y="5292889"/>
            <a:chExt cx="686116" cy="806434"/>
          </a:xfrm>
        </p:grpSpPr>
        <p:pic>
          <p:nvPicPr>
            <p:cNvPr id="26" name="Picture 25" descr="A close-up of a black and white image&#10;&#10;Description automatically generated">
              <a:extLst>
                <a:ext uri="{FF2B5EF4-FFF2-40B4-BE49-F238E27FC236}">
                  <a16:creationId xmlns:a16="http://schemas.microsoft.com/office/drawing/2014/main" id="{7EEFD4F3-F2A5-AE27-7AC2-FFF555E539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5235" t="35129" r="67278" b="6521"/>
            <a:stretch/>
          </p:blipFill>
          <p:spPr>
            <a:xfrm>
              <a:off x="2473851" y="5292889"/>
              <a:ext cx="686116" cy="803111"/>
            </a:xfrm>
            <a:prstGeom prst="rect">
              <a:avLst/>
            </a:prstGeom>
          </p:spPr>
        </p:pic>
        <p:pic>
          <p:nvPicPr>
            <p:cNvPr id="24" name="Picture 23" descr="A black and white image of a line&#10;&#10;Description automatically generated">
              <a:extLst>
                <a:ext uri="{FF2B5EF4-FFF2-40B4-BE49-F238E27FC236}">
                  <a16:creationId xmlns:a16="http://schemas.microsoft.com/office/drawing/2014/main" id="{D0C62831-0817-6D2C-AE5F-3E38057DD4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5517" t="50000" r="67250" b="8045"/>
            <a:stretch/>
          </p:blipFill>
          <p:spPr>
            <a:xfrm>
              <a:off x="2473851" y="5500458"/>
              <a:ext cx="686116" cy="598865"/>
            </a:xfrm>
            <a:prstGeom prst="rect">
              <a:avLst/>
            </a:prstGeom>
          </p:spPr>
        </p:pic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8D043E22-847C-2992-88E5-667D688A1FD9}"/>
              </a:ext>
            </a:extLst>
          </p:cNvPr>
          <p:cNvSpPr txBox="1"/>
          <p:nvPr/>
        </p:nvSpPr>
        <p:spPr>
          <a:xfrm>
            <a:off x="1393371" y="3710637"/>
            <a:ext cx="734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- Tubul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BF5B0B2-7A91-8B62-DE7E-26FAB11C84E0}"/>
              </a:ext>
            </a:extLst>
          </p:cNvPr>
          <p:cNvSpPr txBox="1"/>
          <p:nvPr/>
        </p:nvSpPr>
        <p:spPr>
          <a:xfrm>
            <a:off x="1385420" y="3950358"/>
            <a:ext cx="5817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- GFP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EFA6A9D-B183-3162-B50F-72FE5CF9E538}"/>
              </a:ext>
            </a:extLst>
          </p:cNvPr>
          <p:cNvSpPr txBox="1"/>
          <p:nvPr/>
        </p:nvSpPr>
        <p:spPr>
          <a:xfrm>
            <a:off x="823251" y="3516014"/>
            <a:ext cx="381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EV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FCD6DE8-3C91-815F-E0A1-FCAEE87DD5E2}"/>
              </a:ext>
            </a:extLst>
          </p:cNvPr>
          <p:cNvSpPr txBox="1"/>
          <p:nvPr/>
        </p:nvSpPr>
        <p:spPr>
          <a:xfrm>
            <a:off x="1091962" y="3516014"/>
            <a:ext cx="541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hsp-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4D55064-209D-C75C-25E2-63912844EA0A}"/>
              </a:ext>
            </a:extLst>
          </p:cNvPr>
          <p:cNvSpPr txBox="1"/>
          <p:nvPr/>
        </p:nvSpPr>
        <p:spPr>
          <a:xfrm>
            <a:off x="186898" y="4908711"/>
            <a:ext cx="381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2128E3B-57A4-314A-6F1A-641DAC724E57}"/>
              </a:ext>
            </a:extLst>
          </p:cNvPr>
          <p:cNvSpPr txBox="1"/>
          <p:nvPr/>
        </p:nvSpPr>
        <p:spPr>
          <a:xfrm>
            <a:off x="629322" y="4977165"/>
            <a:ext cx="48576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yo-</a:t>
            </a:r>
            <a:r>
              <a:rPr lang="en-US" sz="10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p::polyQ35::YFP; sur</a:t>
            </a:r>
            <a:r>
              <a:rPr lang="en-US" sz="1000" i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-5</a:t>
            </a:r>
            <a:r>
              <a:rPr lang="en-US" sz="10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::</a:t>
            </a:r>
            <a:r>
              <a:rPr lang="en-US" sz="1000" i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xbp-1s</a:t>
            </a:r>
            <a:r>
              <a:rPr lang="en-US" sz="10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en-US" sz="1000" i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yo-2</a:t>
            </a:r>
            <a:r>
              <a:rPr lang="en-US" sz="10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::</a:t>
            </a:r>
            <a:r>
              <a:rPr lang="en-US" sz="1000" u="sng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dTomato</a:t>
            </a:r>
            <a:r>
              <a:rPr lang="en-US" sz="1000" u="sng" dirty="0">
                <a:effectLst/>
              </a:rPr>
              <a:t> </a:t>
            </a:r>
            <a:endParaRPr lang="en-US" sz="1000" u="sng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A0A5C88-D93A-3E2B-3525-5941B64538BA}"/>
              </a:ext>
            </a:extLst>
          </p:cNvPr>
          <p:cNvSpPr txBox="1"/>
          <p:nvPr/>
        </p:nvSpPr>
        <p:spPr>
          <a:xfrm>
            <a:off x="1347429" y="552388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u="sng" dirty="0"/>
              <a:t>hsp-4</a:t>
            </a:r>
            <a:r>
              <a:rPr lang="en-US" sz="1200" u="sng" dirty="0"/>
              <a:t>p::GF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11DE92C-60A0-D0AA-2F88-B6A9B5873FD8}"/>
              </a:ext>
            </a:extLst>
          </p:cNvPr>
          <p:cNvSpPr txBox="1"/>
          <p:nvPr/>
        </p:nvSpPr>
        <p:spPr>
          <a:xfrm>
            <a:off x="2451610" y="3542120"/>
            <a:ext cx="381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EV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6E7549C-A18D-331C-6821-C38D5151D797}"/>
              </a:ext>
            </a:extLst>
          </p:cNvPr>
          <p:cNvSpPr txBox="1"/>
          <p:nvPr/>
        </p:nvSpPr>
        <p:spPr>
          <a:xfrm>
            <a:off x="2720321" y="3542120"/>
            <a:ext cx="541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hsp-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E34682A-4311-2637-EFBC-BFF902B37CC4}"/>
              </a:ext>
            </a:extLst>
          </p:cNvPr>
          <p:cNvSpPr txBox="1"/>
          <p:nvPr/>
        </p:nvSpPr>
        <p:spPr>
          <a:xfrm>
            <a:off x="2991280" y="3737254"/>
            <a:ext cx="734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- Tubul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771BAB3-B7E4-50AA-CC59-7735190C2535}"/>
              </a:ext>
            </a:extLst>
          </p:cNvPr>
          <p:cNvSpPr txBox="1"/>
          <p:nvPr/>
        </p:nvSpPr>
        <p:spPr>
          <a:xfrm>
            <a:off x="2993981" y="3899191"/>
            <a:ext cx="9952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- DAF-28::GFP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EE629343-45C7-7B90-1385-2118E92477C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47418" y="5278043"/>
            <a:ext cx="3619500" cy="227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6958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DDCBD51-D935-00E3-5E14-52C2F61753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171700"/>
            <a:ext cx="6858000" cy="4800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A28419D-5AAD-8F37-8AF3-366048E040C4}"/>
              </a:ext>
            </a:extLst>
          </p:cNvPr>
          <p:cNvSpPr txBox="1"/>
          <p:nvPr/>
        </p:nvSpPr>
        <p:spPr>
          <a:xfrm>
            <a:off x="0" y="870295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1963723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94201</TotalTime>
  <Words>92</Words>
  <Application>Microsoft Macintosh PowerPoint</Application>
  <PresentationFormat>Letter Paper (8.5x11 in)</PresentationFormat>
  <Paragraphs>41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xlife</dc:creator>
  <cp:lastModifiedBy>Kim, Hyun-Eui</cp:lastModifiedBy>
  <cp:revision>31</cp:revision>
  <dcterms:created xsi:type="dcterms:W3CDTF">2023-06-26T17:08:52Z</dcterms:created>
  <dcterms:modified xsi:type="dcterms:W3CDTF">2024-09-14T01:13:48Z</dcterms:modified>
</cp:coreProperties>
</file>